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media/image2.svg" ContentType="image/svg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sldIdLst>
    <p:sldId id="258" r:id="rId3"/>
  </p:sldIdLst>
  <p:sldSz cx="9144000" cy="6858000" type="screen4x3"/>
  <p:notesSz cx="6858000" cy="9144000"/>
  <p:custDataLst>
    <p:tags r:id="rId7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75" d="100"/>
          <a:sy n="75" d="100"/>
        </p:scale>
        <p:origin x="1004" y="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2.sv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/>
          <p:cNvSpPr txBox="1"/>
          <p:nvPr/>
        </p:nvSpPr>
        <p:spPr>
          <a:xfrm>
            <a:off x="276501" y="4084196"/>
            <a:ext cx="8590998" cy="8299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</a:t>
            </a:r>
            <a:r>
              <a:rPr lang="en-US" altLang="zh-CN" sz="12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3</a:t>
            </a:r>
            <a:r>
              <a:rPr lang="en-US" altLang="zh-CN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Analyses of postoperative ctDNA-negative patients with disease relapse.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 Negative predictive value of undetectable ctDNA during longitudinal surveillance across different stages. (B)</a:t>
            </a:r>
            <a:r>
              <a:rPr lang="en-US" altLang="zh-CN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vent charts showing disease-free survival, longitudinal surveillance ctDNA detection points, and clinical characteristic in patients with negative postoperative ctDNA but experienced recurrence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D, adenocarcinoma; SCC, squamous-cell carcinoma; ASCC,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adenosquamous</a:t>
            </a:r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 carcinoma.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276501" y="1156537"/>
            <a:ext cx="8590999" cy="2786357"/>
            <a:chOff x="276501" y="1156537"/>
            <a:chExt cx="8590999" cy="2786357"/>
          </a:xfrm>
        </p:grpSpPr>
        <p:pic>
          <p:nvPicPr>
            <p:cNvPr id="5" name="图形 4"/>
            <p:cNvPicPr>
              <a:picLocks noChangeAspect="1"/>
            </p:cNvPicPr>
            <p:nvPr/>
          </p:nvPicPr>
          <p:blipFill>
            <a:blip r:embed="rId1">
              <a:extLst>
                <a:ext uri="{96DAC541-7B7A-43D3-8B79-37D633B846F1}">
                  <asvg:svgBlip xmlns:asvg="http://schemas.microsoft.com/office/drawing/2016/SVG/main" r:embed="rId2"/>
                </a:ext>
              </a:extLst>
            </a:blip>
            <a:stretch>
              <a:fillRect/>
            </a:stretch>
          </p:blipFill>
          <p:spPr>
            <a:xfrm>
              <a:off x="276501" y="1156537"/>
              <a:ext cx="8590999" cy="2750924"/>
            </a:xfrm>
            <a:prstGeom prst="rect">
              <a:avLst/>
            </a:prstGeom>
          </p:spPr>
        </p:pic>
        <p:sp>
          <p:nvSpPr>
            <p:cNvPr id="4" name="矩形 3"/>
            <p:cNvSpPr/>
            <p:nvPr/>
          </p:nvSpPr>
          <p:spPr>
            <a:xfrm>
              <a:off x="4686300" y="3778250"/>
              <a:ext cx="1187450" cy="1165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4559300" y="3727450"/>
              <a:ext cx="14986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ime since surgery (months)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adc0015f-a85e-4dcb-974d-f2a826d0cd7e"/>
  <p:tag name="COMMONDATA" val="eyJoZGlkIjoiZjJkNmJiODU1NzA1YWVjNGUwNTk3ZDA3NTIxZGRlMDUifQ=="/>
</p:tagLst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98</Words>
  <Application>WPS 演示</Application>
  <PresentationFormat>全屏显示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Calibri</vt:lpstr>
      <vt:lpstr>Times New Roman</vt:lpstr>
      <vt:lpstr>微软雅黑</vt:lpstr>
      <vt:lpstr>Arial Unicode MS</vt:lpstr>
      <vt:lpstr>等线 Light</vt:lpstr>
      <vt:lpstr>Calibri Light</vt:lpstr>
      <vt:lpstr>等线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eneplus</dc:creator>
  <cp:lastModifiedBy>熊歪歪</cp:lastModifiedBy>
  <cp:revision>30</cp:revision>
  <dcterms:created xsi:type="dcterms:W3CDTF">2022-12-19T12:12:00Z</dcterms:created>
  <dcterms:modified xsi:type="dcterms:W3CDTF">2023-01-29T13:26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D74A3FC939243238FFA33F338A39700</vt:lpwstr>
  </property>
  <property fmtid="{D5CDD505-2E9C-101B-9397-08002B2CF9AE}" pid="3" name="KSOProductBuildVer">
    <vt:lpwstr>2052-11.1.0.13703</vt:lpwstr>
  </property>
</Properties>
</file>